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907588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711000" y="744120"/>
            <a:ext cx="537516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5B7AC27-19F9-4E4E-AD0D-443577C57994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PlaceHolder 1"/>
          <p:cNvSpPr>
            <a:spLocks noGrp="1"/>
          </p:cNvSpPr>
          <p:nvPr>
            <p:ph type="sldImg"/>
          </p:nvPr>
        </p:nvSpPr>
        <p:spPr>
          <a:xfrm>
            <a:off x="711360" y="744480"/>
            <a:ext cx="5375160" cy="3722760"/>
          </a:xfrm>
          <a:prstGeom prst="rect">
            <a:avLst/>
          </a:prstGeom>
          <a:ln w="0">
            <a:noFill/>
          </a:ln>
        </p:spPr>
      </p:sp>
      <p:sp>
        <p:nvSpPr>
          <p:cNvPr id="114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lnSpc>
                <a:spcPct val="10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ffects of ds-miR-655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urchased from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harmacon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スライド番号プレースホルダー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0FA7B29-797E-4B6F-9AB2-D4A329AFDB3C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41A581-F2B8-4B8F-BE12-100641C78FC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D2C1B8-4F4A-40F4-9831-EDAE437F7A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182D42-4D82-4F9D-9DD9-849F318349E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64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428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00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64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428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F1CF3E-5258-475A-ACF2-A8F8B8F6D06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DC7399-D09B-4B0D-A67C-D0203A5F87C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B702C7-26E6-451E-B963-4FBE9CABB6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EF84A4-9430-4643-B762-4DDD8B99D18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74D0C1-944F-4B90-ADE8-6921966F32C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000" y="274320"/>
            <a:ext cx="8915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BDC7DE-0191-49A1-964C-A0AC83B2105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B49633-F513-42BB-B5D3-C1B7E13E90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B4324D-5E77-404E-AF0B-81D6DADBE7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A6BB69-8B88-4DD2-81D4-0FC2E8E53E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6356520"/>
            <a:ext cx="2311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Arial"/>
                <a:ea typeface="HGSｺﾞｼｯｸE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Arial"/>
                <a:ea typeface="HGSｺﾞｼｯｸE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6356520"/>
            <a:ext cx="31366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6356520"/>
            <a:ext cx="23115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Arial"/>
                <a:ea typeface="HGSｺﾞｼｯｸE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58450DD-A8A5-4DDF-B500-8E475124CDB2}" type="slidenum">
              <a:rPr b="0" lang="ja-JP" sz="1200" spc="-1" strike="noStrike">
                <a:solidFill>
                  <a:srgbClr val="898989"/>
                </a:solidFill>
                <a:latin typeface="Arial"/>
                <a:ea typeface="HGSｺﾞｼｯｸE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<Relationship Id="rId10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テキスト ボックス 97"/>
          <p:cNvSpPr/>
          <p:nvPr/>
        </p:nvSpPr>
        <p:spPr>
          <a:xfrm>
            <a:off x="146160" y="139680"/>
            <a:ext cx="231408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. 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直線コネクタ 142"/>
          <p:cNvSpPr/>
          <p:nvPr/>
        </p:nvSpPr>
        <p:spPr>
          <a:xfrm>
            <a:off x="5043600" y="3827520"/>
            <a:ext cx="889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直線コネクタ 144"/>
          <p:cNvSpPr/>
          <p:nvPr/>
        </p:nvSpPr>
        <p:spPr>
          <a:xfrm>
            <a:off x="5087880" y="3827520"/>
            <a:ext cx="0" cy="172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直線コネクタ 145"/>
          <p:cNvSpPr/>
          <p:nvPr/>
        </p:nvSpPr>
        <p:spPr>
          <a:xfrm>
            <a:off x="5710320" y="3836880"/>
            <a:ext cx="889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直線コネクタ 146"/>
          <p:cNvSpPr/>
          <p:nvPr/>
        </p:nvSpPr>
        <p:spPr>
          <a:xfrm>
            <a:off x="5754600" y="3836880"/>
            <a:ext cx="0" cy="11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直線コネクタ 148"/>
          <p:cNvSpPr/>
          <p:nvPr/>
        </p:nvSpPr>
        <p:spPr>
          <a:xfrm>
            <a:off x="4589640" y="3510000"/>
            <a:ext cx="885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直線コネクタ 157"/>
          <p:cNvSpPr/>
          <p:nvPr/>
        </p:nvSpPr>
        <p:spPr>
          <a:xfrm>
            <a:off x="4633920" y="3510000"/>
            <a:ext cx="0" cy="28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直線コネクタ 159"/>
          <p:cNvSpPr/>
          <p:nvPr/>
        </p:nvSpPr>
        <p:spPr>
          <a:xfrm>
            <a:off x="4402080" y="3828960"/>
            <a:ext cx="921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直線コネクタ 160"/>
          <p:cNvSpPr/>
          <p:nvPr/>
        </p:nvSpPr>
        <p:spPr>
          <a:xfrm>
            <a:off x="4446720" y="3828960"/>
            <a:ext cx="0" cy="176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直線コネクタ 163"/>
          <p:cNvSpPr/>
          <p:nvPr/>
        </p:nvSpPr>
        <p:spPr>
          <a:xfrm>
            <a:off x="5230800" y="3697200"/>
            <a:ext cx="889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直線コネクタ 164"/>
          <p:cNvSpPr/>
          <p:nvPr/>
        </p:nvSpPr>
        <p:spPr>
          <a:xfrm>
            <a:off x="5275440" y="3697200"/>
            <a:ext cx="0" cy="11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正方形/長方形 166"/>
          <p:cNvSpPr/>
          <p:nvPr/>
        </p:nvSpPr>
        <p:spPr>
          <a:xfrm>
            <a:off x="4125960" y="1746360"/>
            <a:ext cx="2144520" cy="229068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テキスト ボックス 1322"/>
          <p:cNvSpPr/>
          <p:nvPr/>
        </p:nvSpPr>
        <p:spPr>
          <a:xfrm rot="16200000">
            <a:off x="2642400" y="2822400"/>
            <a:ext cx="2224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HGSｺﾞｼｯｸE"/>
              </a:rPr>
              <a:t>Relative expression ratio of </a:t>
            </a:r>
            <a:r>
              <a:rPr b="1" i="1" lang="en-US" sz="900" spc="-1" strike="noStrike">
                <a:solidFill>
                  <a:srgbClr val="000000"/>
                </a:solidFill>
                <a:latin typeface="Arial"/>
                <a:ea typeface="HGSｺﾞｼｯｸE"/>
              </a:rPr>
              <a:t>CDH1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  <a:ea typeface="HGSｺﾞｼｯｸE"/>
              </a:rPr>
              <a:t> mRN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テキスト ボックス 168"/>
          <p:cNvSpPr/>
          <p:nvPr/>
        </p:nvSpPr>
        <p:spPr>
          <a:xfrm>
            <a:off x="4328640" y="5592600"/>
            <a:ext cx="37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anc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正方形/長方形 169"/>
          <p:cNvSpPr/>
          <p:nvPr/>
        </p:nvSpPr>
        <p:spPr>
          <a:xfrm>
            <a:off x="4992840" y="3844800"/>
            <a:ext cx="187200" cy="19224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テキスト ボックス 170"/>
          <p:cNvSpPr/>
          <p:nvPr/>
        </p:nvSpPr>
        <p:spPr>
          <a:xfrm>
            <a:off x="5027760" y="5592600"/>
            <a:ext cx="337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KP1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正方形/長方形 172"/>
          <p:cNvSpPr/>
          <p:nvPr/>
        </p:nvSpPr>
        <p:spPr>
          <a:xfrm>
            <a:off x="5662440" y="3844800"/>
            <a:ext cx="187560" cy="19224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テキスト ボックス 174"/>
          <p:cNvSpPr/>
          <p:nvPr/>
        </p:nvSpPr>
        <p:spPr>
          <a:xfrm>
            <a:off x="5591880" y="5592600"/>
            <a:ext cx="780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DA-MB-23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正方形/長方形 175"/>
          <p:cNvSpPr/>
          <p:nvPr/>
        </p:nvSpPr>
        <p:spPr>
          <a:xfrm>
            <a:off x="4540320" y="3540240"/>
            <a:ext cx="187200" cy="4968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正方形/長方形 176"/>
          <p:cNvSpPr/>
          <p:nvPr/>
        </p:nvSpPr>
        <p:spPr>
          <a:xfrm>
            <a:off x="4354560" y="3844800"/>
            <a:ext cx="187200" cy="19224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直線コネクタ 186"/>
          <p:cNvSpPr/>
          <p:nvPr/>
        </p:nvSpPr>
        <p:spPr>
          <a:xfrm>
            <a:off x="4089240" y="3463920"/>
            <a:ext cx="367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直線コネクタ 187"/>
          <p:cNvSpPr/>
          <p:nvPr/>
        </p:nvSpPr>
        <p:spPr>
          <a:xfrm>
            <a:off x="4089240" y="3844800"/>
            <a:ext cx="367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直線コネクタ 188"/>
          <p:cNvSpPr/>
          <p:nvPr/>
        </p:nvSpPr>
        <p:spPr>
          <a:xfrm>
            <a:off x="4089240" y="2892600"/>
            <a:ext cx="367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テキスト ボックス 1349"/>
          <p:cNvSpPr/>
          <p:nvPr/>
        </p:nvSpPr>
        <p:spPr>
          <a:xfrm>
            <a:off x="3978360" y="340524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テキスト ボックス 1350"/>
          <p:cNvSpPr/>
          <p:nvPr/>
        </p:nvSpPr>
        <p:spPr>
          <a:xfrm>
            <a:off x="3978360" y="28288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テキスト ボックス 1351"/>
          <p:cNvSpPr/>
          <p:nvPr/>
        </p:nvSpPr>
        <p:spPr>
          <a:xfrm>
            <a:off x="3978360" y="378000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テキスト ボックス 1352"/>
          <p:cNvSpPr/>
          <p:nvPr/>
        </p:nvSpPr>
        <p:spPr>
          <a:xfrm>
            <a:off x="3978360" y="397836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テキスト ボックス 1353"/>
          <p:cNvSpPr/>
          <p:nvPr/>
        </p:nvSpPr>
        <p:spPr>
          <a:xfrm>
            <a:off x="3978360" y="225756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直線コネクタ 194"/>
          <p:cNvSpPr/>
          <p:nvPr/>
        </p:nvSpPr>
        <p:spPr>
          <a:xfrm>
            <a:off x="4089240" y="4037040"/>
            <a:ext cx="367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直線コネクタ 195"/>
          <p:cNvSpPr/>
          <p:nvPr/>
        </p:nvSpPr>
        <p:spPr>
          <a:xfrm>
            <a:off x="4089240" y="2319480"/>
            <a:ext cx="367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直線コネクタ 196"/>
          <p:cNvSpPr/>
          <p:nvPr/>
        </p:nvSpPr>
        <p:spPr>
          <a:xfrm>
            <a:off x="4089240" y="1746360"/>
            <a:ext cx="367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テキスト ボックス 1357"/>
          <p:cNvSpPr/>
          <p:nvPr/>
        </p:nvSpPr>
        <p:spPr>
          <a:xfrm>
            <a:off x="3920760" y="168444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2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テキスト ボックス 198"/>
          <p:cNvSpPr/>
          <p:nvPr/>
        </p:nvSpPr>
        <p:spPr>
          <a:xfrm rot="16200000">
            <a:off x="4087800" y="4992120"/>
            <a:ext cx="5918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ds-</a:t>
            </a:r>
            <a:r>
              <a:rPr b="1" i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miR-N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テキスト ボックス 199"/>
          <p:cNvSpPr/>
          <p:nvPr/>
        </p:nvSpPr>
        <p:spPr>
          <a:xfrm>
            <a:off x="3718800" y="4484520"/>
            <a:ext cx="3697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-act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テキスト ボックス 200"/>
          <p:cNvSpPr/>
          <p:nvPr/>
        </p:nvSpPr>
        <p:spPr>
          <a:xfrm rot="16200000">
            <a:off x="4351320" y="5004360"/>
            <a:ext cx="6195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ds</a:t>
            </a:r>
            <a:r>
              <a:rPr b="1" i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-miR-65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テキスト ボックス 201"/>
          <p:cNvSpPr/>
          <p:nvPr/>
        </p:nvSpPr>
        <p:spPr>
          <a:xfrm>
            <a:off x="3493800" y="4210200"/>
            <a:ext cx="5936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E-cadher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直線コネクタ 202"/>
          <p:cNvSpPr/>
          <p:nvPr/>
        </p:nvSpPr>
        <p:spPr>
          <a:xfrm>
            <a:off x="4227480" y="5504040"/>
            <a:ext cx="576360" cy="0"/>
          </a:xfrm>
          <a:prstGeom prst="line">
            <a:avLst/>
          </a:prstGeom>
          <a:ln w="31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テキスト ボックス 203"/>
          <p:cNvSpPr/>
          <p:nvPr/>
        </p:nvSpPr>
        <p:spPr>
          <a:xfrm rot="16200000">
            <a:off x="4759200" y="4992120"/>
            <a:ext cx="5918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ds-</a:t>
            </a:r>
            <a:r>
              <a:rPr b="1" i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miR-N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テキスト ボックス 204"/>
          <p:cNvSpPr/>
          <p:nvPr/>
        </p:nvSpPr>
        <p:spPr>
          <a:xfrm rot="16200000">
            <a:off x="5037120" y="5004360"/>
            <a:ext cx="6195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ds</a:t>
            </a:r>
            <a:r>
              <a:rPr b="1" i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-miR-65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直線コネクタ 205"/>
          <p:cNvSpPr/>
          <p:nvPr/>
        </p:nvSpPr>
        <p:spPr>
          <a:xfrm>
            <a:off x="4908600" y="5504040"/>
            <a:ext cx="576360" cy="0"/>
          </a:xfrm>
          <a:prstGeom prst="line">
            <a:avLst/>
          </a:prstGeom>
          <a:ln w="31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テキスト ボックス 206"/>
          <p:cNvSpPr/>
          <p:nvPr/>
        </p:nvSpPr>
        <p:spPr>
          <a:xfrm rot="16200000">
            <a:off x="5446440" y="4992120"/>
            <a:ext cx="5918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ds-</a:t>
            </a:r>
            <a:r>
              <a:rPr b="1" i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miR-N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テキスト ボックス 207"/>
          <p:cNvSpPr/>
          <p:nvPr/>
        </p:nvSpPr>
        <p:spPr>
          <a:xfrm rot="16200000">
            <a:off x="5720040" y="5004360"/>
            <a:ext cx="6195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ds</a:t>
            </a:r>
            <a:r>
              <a:rPr b="1" i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-miR-65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直線コネクタ 208"/>
          <p:cNvSpPr/>
          <p:nvPr/>
        </p:nvSpPr>
        <p:spPr>
          <a:xfrm>
            <a:off x="5586480" y="5504040"/>
            <a:ext cx="576360" cy="0"/>
          </a:xfrm>
          <a:prstGeom prst="line">
            <a:avLst/>
          </a:prstGeom>
          <a:ln w="31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1" name="Picture 2" descr="C:\Users\yosuke harazono\Desktop\分子細胞遺伝\Western Blotting\110603 Panc1 NT siNC siZEB1 X2_ZEB1,E-cadherin DNT DNC D520d D655_E-cadherin,VIM\20110603_Panc1 DNT DNC D520d D655 NT NC 526b_E-cadherin.img.tif"/>
          <p:cNvPicPr/>
          <p:nvPr/>
        </p:nvPicPr>
        <p:blipFill>
          <a:blip r:embed="rId1"/>
          <a:srcRect l="35976" t="39177" r="56538" b="54441"/>
          <a:stretch/>
        </p:blipFill>
        <p:spPr>
          <a:xfrm>
            <a:off x="4227480" y="4162320"/>
            <a:ext cx="325440" cy="216000"/>
          </a:xfrm>
          <a:prstGeom prst="rect">
            <a:avLst/>
          </a:prstGeom>
          <a:ln w="0">
            <a:noFill/>
          </a:ln>
        </p:spPr>
      </p:pic>
      <p:pic>
        <p:nvPicPr>
          <p:cNvPr id="92" name="Picture 2" descr="C:\Users\yosuke harazono\Desktop\分子細胞遺伝\Western Blotting\110603 Panc1 NT siNC siZEB1 X2_ZEB1,E-cadherin DNT DNC D520d D655_E-cadherin,VIM\20110603_Panc1 DNT DNC D520d D655 NT NC 526b_E-cadherin.img.tif"/>
          <p:cNvPicPr/>
          <p:nvPr/>
        </p:nvPicPr>
        <p:blipFill>
          <a:blip r:embed="rId2"/>
          <a:srcRect l="50263" t="38638" r="43768" b="55101"/>
          <a:stretch/>
        </p:blipFill>
        <p:spPr>
          <a:xfrm>
            <a:off x="4540320" y="4162320"/>
            <a:ext cx="263520" cy="216000"/>
          </a:xfrm>
          <a:prstGeom prst="rect">
            <a:avLst/>
          </a:prstGeom>
          <a:ln w="0">
            <a:noFill/>
          </a:ln>
        </p:spPr>
      </p:pic>
      <p:sp>
        <p:nvSpPr>
          <p:cNvPr id="93" name="正方形/長方形 211"/>
          <p:cNvSpPr/>
          <p:nvPr/>
        </p:nvSpPr>
        <p:spPr>
          <a:xfrm>
            <a:off x="4227480" y="4160880"/>
            <a:ext cx="576360" cy="21888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4" name="Picture 3" descr="C:\Users\yosuke harazono\Desktop\分子細胞遺伝\Western Blotting\110603 Panc1 NT siNC siZEB1 X2_ZEB1,E-cadherin DNT DNC D520d D655_E-cadherin,VIM\20110603_Panc1 DNT DNC D520d D655 NT NC 526b_ACTB of E-cadherin.img.tif"/>
          <p:cNvPicPr/>
          <p:nvPr/>
        </p:nvPicPr>
        <p:blipFill>
          <a:blip r:embed="rId3"/>
          <a:srcRect l="41805" t="60009" r="51270" b="31064"/>
          <a:stretch/>
        </p:blipFill>
        <p:spPr>
          <a:xfrm>
            <a:off x="4230720" y="4437000"/>
            <a:ext cx="311040" cy="216000"/>
          </a:xfrm>
          <a:prstGeom prst="rect">
            <a:avLst/>
          </a:prstGeom>
          <a:ln w="0">
            <a:noFill/>
          </a:ln>
        </p:spPr>
      </p:pic>
      <p:pic>
        <p:nvPicPr>
          <p:cNvPr id="95" name="Picture 3" descr="C:\Users\yosuke harazono\Desktop\分子細胞遺伝\Western Blotting\110603 Panc1 NT siNC siZEB1 X2_ZEB1,E-cadherin DNT DNC D520d D655_E-cadherin,VIM\20110603_Panc1 DNT DNC D520d D655 NT NC 526b_ACTB of E-cadherin.img.tif"/>
          <p:cNvPicPr/>
          <p:nvPr/>
        </p:nvPicPr>
        <p:blipFill>
          <a:blip r:embed="rId4"/>
          <a:srcRect l="56267" t="60009" r="37602" b="31064"/>
          <a:stretch/>
        </p:blipFill>
        <p:spPr>
          <a:xfrm>
            <a:off x="4527720" y="4437000"/>
            <a:ext cx="274320" cy="216000"/>
          </a:xfrm>
          <a:prstGeom prst="rect">
            <a:avLst/>
          </a:prstGeom>
          <a:ln w="0">
            <a:noFill/>
          </a:ln>
        </p:spPr>
      </p:pic>
      <p:sp>
        <p:nvSpPr>
          <p:cNvPr id="96" name="正方形/長方形 214"/>
          <p:cNvSpPr/>
          <p:nvPr/>
        </p:nvSpPr>
        <p:spPr>
          <a:xfrm>
            <a:off x="4227480" y="4435560"/>
            <a:ext cx="576360" cy="22068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7" name="Picture 5" descr="D:\VAIO desk top\MCG\Western Blotting\MDAMB231\120529 KP1N 231 Panc1 Dharmacon\20120528_KP1N 231 Panc1 Dharmacon NC 655_actb of e-cadherin.img.tif"/>
          <p:cNvPicPr/>
          <p:nvPr/>
        </p:nvPicPr>
        <p:blipFill>
          <a:blip r:embed="rId5"/>
          <a:srcRect l="23423" t="41659" r="61666" b="51140"/>
          <a:stretch/>
        </p:blipFill>
        <p:spPr>
          <a:xfrm>
            <a:off x="4908600" y="4437000"/>
            <a:ext cx="576360" cy="216000"/>
          </a:xfrm>
          <a:prstGeom prst="rect">
            <a:avLst/>
          </a:prstGeom>
          <a:ln w="3240">
            <a:solidFill>
              <a:srgbClr val="000000"/>
            </a:solidFill>
            <a:miter/>
          </a:ln>
        </p:spPr>
      </p:pic>
      <p:pic>
        <p:nvPicPr>
          <p:cNvPr id="98" name="Picture 4" descr="D:\VAIO desk top\MCG\Western Blotting\MDAMB231\120529 KP1N 231 Panc1 Dharmacon\20120528_KP1N 231 Panc1 Dharmacon NC 655_e-cadherin.tif"/>
          <p:cNvPicPr/>
          <p:nvPr/>
        </p:nvPicPr>
        <p:blipFill>
          <a:blip r:embed="rId6"/>
          <a:srcRect l="20969" t="52133" r="64734" b="41152"/>
          <a:stretch/>
        </p:blipFill>
        <p:spPr>
          <a:xfrm>
            <a:off x="4908600" y="4162320"/>
            <a:ext cx="576360" cy="216000"/>
          </a:xfrm>
          <a:prstGeom prst="rect">
            <a:avLst/>
          </a:prstGeom>
          <a:ln w="3240">
            <a:solidFill>
              <a:srgbClr val="000000"/>
            </a:solidFill>
            <a:miter/>
          </a:ln>
        </p:spPr>
      </p:pic>
      <p:pic>
        <p:nvPicPr>
          <p:cNvPr id="99" name="Picture 4" descr="D:\VAIO desk top\MCG\Western Blotting\MDAMB231\120529 KP1N 231 Panc1 Dharmacon\20120528_KP1N 231 Panc1 Dharmacon NC 655_e-cadherin.tif"/>
          <p:cNvPicPr/>
          <p:nvPr/>
        </p:nvPicPr>
        <p:blipFill>
          <a:blip r:embed="rId7"/>
          <a:srcRect l="40567" t="52136" r="45861" b="41148"/>
          <a:stretch/>
        </p:blipFill>
        <p:spPr>
          <a:xfrm>
            <a:off x="5586480" y="4162320"/>
            <a:ext cx="576360" cy="216000"/>
          </a:xfrm>
          <a:prstGeom prst="rect">
            <a:avLst/>
          </a:prstGeom>
          <a:ln w="3240">
            <a:solidFill>
              <a:srgbClr val="000000"/>
            </a:solidFill>
            <a:miter/>
          </a:ln>
        </p:spPr>
      </p:pic>
      <p:pic>
        <p:nvPicPr>
          <p:cNvPr id="100" name="Picture 5" descr="D:\VAIO desk top\MCG\Western Blotting\MDAMB231\120529 KP1N 231 Panc1 Dharmacon\20120528_KP1N 231 Panc1 Dharmacon NC 655_actb of e-cadherin.img.tif"/>
          <p:cNvPicPr/>
          <p:nvPr/>
        </p:nvPicPr>
        <p:blipFill>
          <a:blip r:embed="rId8"/>
          <a:srcRect l="43125" t="41660" r="42581" b="51897"/>
          <a:stretch/>
        </p:blipFill>
        <p:spPr>
          <a:xfrm>
            <a:off x="5586480" y="4437000"/>
            <a:ext cx="576360" cy="216000"/>
          </a:xfrm>
          <a:prstGeom prst="rect">
            <a:avLst/>
          </a:prstGeom>
          <a:ln w="3240">
            <a:solidFill>
              <a:srgbClr val="000000"/>
            </a:solidFill>
            <a:miter/>
          </a:ln>
        </p:spPr>
      </p:pic>
      <p:sp>
        <p:nvSpPr>
          <p:cNvPr id="101" name="正方形/長方形 219"/>
          <p:cNvSpPr/>
          <p:nvPr/>
        </p:nvSpPr>
        <p:spPr>
          <a:xfrm>
            <a:off x="5181480" y="3710160"/>
            <a:ext cx="187560" cy="32688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正方形/長方形 220"/>
          <p:cNvSpPr/>
          <p:nvPr/>
        </p:nvSpPr>
        <p:spPr>
          <a:xfrm>
            <a:off x="5848200" y="1890720"/>
            <a:ext cx="187560" cy="21463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直線コネクタ 221"/>
          <p:cNvSpPr/>
          <p:nvPr/>
        </p:nvSpPr>
        <p:spPr>
          <a:xfrm>
            <a:off x="5897520" y="1870200"/>
            <a:ext cx="889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直線コネクタ 222"/>
          <p:cNvSpPr/>
          <p:nvPr/>
        </p:nvSpPr>
        <p:spPr>
          <a:xfrm>
            <a:off x="5942160" y="1870200"/>
            <a:ext cx="0" cy="190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正方形/長方形 223"/>
          <p:cNvSpPr/>
          <p:nvPr/>
        </p:nvSpPr>
        <p:spPr>
          <a:xfrm>
            <a:off x="5848200" y="2130480"/>
            <a:ext cx="196920" cy="5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正方形/長方形 224"/>
          <p:cNvSpPr/>
          <p:nvPr/>
        </p:nvSpPr>
        <p:spPr>
          <a:xfrm>
            <a:off x="4056120" y="2130480"/>
            <a:ext cx="144360" cy="5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直線コネクタ 225"/>
          <p:cNvSpPr/>
          <p:nvPr/>
        </p:nvSpPr>
        <p:spPr>
          <a:xfrm>
            <a:off x="5808600" y="2184480"/>
            <a:ext cx="2602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直線コネクタ 226"/>
          <p:cNvSpPr/>
          <p:nvPr/>
        </p:nvSpPr>
        <p:spPr>
          <a:xfrm>
            <a:off x="4056120" y="2184480"/>
            <a:ext cx="144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直線コネクタ 227"/>
          <p:cNvSpPr/>
          <p:nvPr/>
        </p:nvSpPr>
        <p:spPr>
          <a:xfrm>
            <a:off x="5808600" y="2130480"/>
            <a:ext cx="2602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直線コネクタ 228"/>
          <p:cNvSpPr/>
          <p:nvPr/>
        </p:nvSpPr>
        <p:spPr>
          <a:xfrm>
            <a:off x="4056120" y="2130480"/>
            <a:ext cx="144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直線コネクタ 229"/>
          <p:cNvSpPr/>
          <p:nvPr/>
        </p:nvSpPr>
        <p:spPr>
          <a:xfrm>
            <a:off x="4125960" y="3844800"/>
            <a:ext cx="2146320" cy="0"/>
          </a:xfrm>
          <a:prstGeom prst="line">
            <a:avLst/>
          </a:prstGeom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4"/>
          <p:cNvSpPr/>
          <p:nvPr/>
        </p:nvSpPr>
        <p:spPr>
          <a:xfrm>
            <a:off x="8102160" y="169920"/>
            <a:ext cx="16344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Times New Roman"/>
              </a:rPr>
              <a:t>Harazono Y </a:t>
            </a:r>
            <a:r>
              <a:rPr b="1" i="1" lang="en-US" sz="1600" spc="-1" strike="noStrike">
                <a:solidFill>
                  <a:srgbClr val="000000"/>
                </a:solidFill>
                <a:latin typeface="Arial"/>
                <a:ea typeface="Times New Roman"/>
              </a:rPr>
              <a:t>et al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3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15T04:20:50Z</dcterms:created>
  <dc:creator>yosuke harazono</dc:creator>
  <dc:description/>
  <dc:language>en-US</dc:language>
  <cp:lastModifiedBy>MCG</cp:lastModifiedBy>
  <cp:lastPrinted>2012-08-28T05:49:27Z</cp:lastPrinted>
  <dcterms:modified xsi:type="dcterms:W3CDTF">2013-03-12T03:30:31Z</dcterms:modified>
  <cp:revision>270</cp:revision>
  <dc:subject/>
  <dc:title>PowerPoint プレゼンテーション</dc:title>
</cp:coreProperties>
</file>